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-335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450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599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256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185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398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485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3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4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333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641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857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94DDA-E747-1A43-9A1D-8002B78ABFE7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1388E0-C455-144C-A1F0-DACE825ABB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12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0919467"/>
              </p:ext>
            </p:extLst>
          </p:nvPr>
        </p:nvGraphicFramePr>
        <p:xfrm>
          <a:off x="541724" y="2097070"/>
          <a:ext cx="5963920" cy="25958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6000"/>
                <a:gridCol w="1788160"/>
                <a:gridCol w="3159760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Gen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lone</a:t>
                      </a:r>
                      <a:r>
                        <a:rPr lang="en-US" baseline="0" dirty="0" smtClean="0"/>
                        <a:t> ID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Gene target sequenc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3LHS_363219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GGAAGAAAACAGTGCCTA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A9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3LHS_363223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CCTGAAGTTAGAGGATCT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2LHS_112665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TGTCTCGCTTGGAAGAAA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3LHS_406183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AGGTGTTCTCTGTAGCTCA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A12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3LHS_344226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CCAGAGAAATGATCAACA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V2LHS_112680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TTTGAATCTGGAGGAAAT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74163" y="8679233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1 Table  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62488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Macintosh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rost</dc:creator>
  <cp:lastModifiedBy>Susan Frost</cp:lastModifiedBy>
  <cp:revision>1</cp:revision>
  <dcterms:created xsi:type="dcterms:W3CDTF">2018-06-13T18:16:25Z</dcterms:created>
  <dcterms:modified xsi:type="dcterms:W3CDTF">2018-06-13T18:16:56Z</dcterms:modified>
</cp:coreProperties>
</file>